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56" r:id="rId2"/>
    <p:sldId id="276" r:id="rId3"/>
    <p:sldId id="275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69"/>
    <p:restoredTop sz="83359"/>
  </p:normalViewPr>
  <p:slideViewPr>
    <p:cSldViewPr snapToGrid="0">
      <p:cViewPr>
        <p:scale>
          <a:sx n="254" d="100"/>
          <a:sy n="254" d="100"/>
        </p:scale>
        <p:origin x="192" y="-57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815C4B-290A-FB49-ADEE-0A4D60D14A2D}" type="datetimeFigureOut">
              <a:rPr lang="en-US" smtClean="0"/>
              <a:t>9/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C42E19-1F9B-5049-B6A5-48F2FF964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3438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C42E19-1F9B-5049-B6A5-48F2FF96487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4335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5" indent="0" algn="ctr">
              <a:buNone/>
              <a:defRPr sz="1500"/>
            </a:lvl2pPr>
            <a:lvl3pPr marL="685808" indent="0" algn="ctr">
              <a:buNone/>
              <a:defRPr sz="1350"/>
            </a:lvl3pPr>
            <a:lvl4pPr marL="1028713" indent="0" algn="ctr">
              <a:buNone/>
              <a:defRPr sz="1200"/>
            </a:lvl4pPr>
            <a:lvl5pPr marL="1371617" indent="0" algn="ctr">
              <a:buNone/>
              <a:defRPr sz="1200"/>
            </a:lvl5pPr>
            <a:lvl6pPr marL="1714521" indent="0" algn="ctr">
              <a:buNone/>
              <a:defRPr sz="1200"/>
            </a:lvl6pPr>
            <a:lvl7pPr marL="2057426" indent="0" algn="ctr">
              <a:buNone/>
              <a:defRPr sz="1200"/>
            </a:lvl7pPr>
            <a:lvl8pPr marL="2400330" indent="0" algn="ctr">
              <a:buNone/>
              <a:defRPr sz="1200"/>
            </a:lvl8pPr>
            <a:lvl9pPr marL="2743234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65199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21358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70100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37179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76459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17649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8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64333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15903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34933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431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5" indent="0">
              <a:buNone/>
              <a:defRPr sz="2100"/>
            </a:lvl2pPr>
            <a:lvl3pPr marL="685808" indent="0">
              <a:buNone/>
              <a:defRPr sz="1800"/>
            </a:lvl3pPr>
            <a:lvl4pPr marL="1028713" indent="0">
              <a:buNone/>
              <a:defRPr sz="1500"/>
            </a:lvl4pPr>
            <a:lvl5pPr marL="1371617" indent="0">
              <a:buNone/>
              <a:defRPr sz="1500"/>
            </a:lvl5pPr>
            <a:lvl6pPr marL="1714521" indent="0">
              <a:buNone/>
              <a:defRPr sz="1500"/>
            </a:lvl6pPr>
            <a:lvl7pPr marL="2057426" indent="0">
              <a:buNone/>
              <a:defRPr sz="1500"/>
            </a:lvl7pPr>
            <a:lvl8pPr marL="2400330" indent="0">
              <a:buNone/>
              <a:defRPr sz="1500"/>
            </a:lvl8pPr>
            <a:lvl9pPr marL="2743234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43049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8632FD-C224-9C4F-804A-97FCD0DCE4DD}" type="datetimeFigureOut">
              <a:rPr lang="de-CH" smtClean="0"/>
              <a:t>01.09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11300182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93626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2" indent="-171452" algn="l" defTabSz="68580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6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1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65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69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74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78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82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87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5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8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13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17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21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26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3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34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4187A3B7-1C1C-9C3A-26B9-FCE3F84801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8518309"/>
              </p:ext>
            </p:extLst>
          </p:nvPr>
        </p:nvGraphicFramePr>
        <p:xfrm>
          <a:off x="755232" y="1060120"/>
          <a:ext cx="4900295" cy="679529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42695">
                  <a:extLst>
                    <a:ext uri="{9D8B030D-6E8A-4147-A177-3AD203B41FA5}">
                      <a16:colId xmlns:a16="http://schemas.microsoft.com/office/drawing/2014/main" val="46098115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543340868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231682253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53508996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954700391"/>
                    </a:ext>
                  </a:extLst>
                </a:gridCol>
              </a:tblGrid>
              <a:tr h="334329"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cohort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y retina group at study inclusion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d retina group at study inclusion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s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74812778"/>
                  </a:ext>
                </a:extLst>
              </a:tr>
              <a:tr h="334329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s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1 (57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 (43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 (55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 (45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 (60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 (40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5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0.4, </a:t>
                      </a:r>
                      <a:r>
                        <a:rPr lang="en-US" sz="600" noProof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0954702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r>
                        <a:rPr lang="en-US" sz="600" b="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years)</a:t>
                      </a:r>
                    </a:p>
                    <a:p>
                      <a:r>
                        <a:rPr lang="en-US" sz="600" b="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b="0" noProof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b="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± 18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: 9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 ± 18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: 86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 ± 11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 : 9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= -10; </a:t>
                      </a:r>
                      <a:r>
                        <a:rPr lang="en-US" sz="600" noProof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09</a:t>
                      </a:r>
                    </a:p>
                    <a:p>
                      <a:r>
                        <a:rPr lang="en-US" sz="600" noProof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f.int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[-23, -16]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5198759"/>
                  </a:ext>
                </a:extLst>
              </a:tr>
              <a:tr h="334329">
                <a:tc>
                  <a:txBody>
                    <a:bodyPr/>
                    <a:lstStyle/>
                    <a:p>
                      <a:r>
                        <a:rPr lang="en-US" sz="600" b="1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verse events 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ent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t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 (94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6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 (94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6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 (95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8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0.05, </a:t>
                      </a:r>
                      <a:r>
                        <a:rPr lang="en-US" sz="600" noProof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2234296"/>
                  </a:ext>
                </a:extLst>
              </a:tr>
              <a:tr h="334329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yes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7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6 (49%) 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 (51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1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 (49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 (51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 (50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 (50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9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0.02, </a:t>
                      </a:r>
                      <a:r>
                        <a:rPr lang="en-US" sz="600" noProof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8631259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nes imaged of 431 eyes 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 </a:t>
                      </a:r>
                    </a:p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3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5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9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6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9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6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9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4,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1734233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ual acuity ETDRS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 ± 12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: 95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 ± 8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 : 95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 ± 14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 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: 95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32726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46956564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herical equivalent 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D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 ± 2.3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4.2 : 4.6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 ± 2.7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4.2 : 3.8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 ± 1.6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4 : 4.6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19396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62499667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xial length 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m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6 ± 1.2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4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7 : 29.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8 ± 1.3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6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8 : 29.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3 ± 1.1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2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7 : 26.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29102</a:t>
                      </a:r>
                    </a:p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8119775"/>
                  </a:ext>
                </a:extLst>
              </a:tr>
              <a:tr h="334329">
                <a:tc>
                  <a:txBody>
                    <a:bodyPr/>
                    <a:lstStyle/>
                    <a:p>
                      <a:r>
                        <a:rPr lang="en-US" sz="600" b="1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igmatism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600" b="1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 1.5D 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ent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t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6 (84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 (16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 (90%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(10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 (77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 (23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13, </a:t>
                      </a:r>
                      <a:r>
                        <a:rPr lang="en-US" sz="600" noProof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11500376"/>
                  </a:ext>
                </a:extLst>
              </a:tr>
              <a:tr h="522924">
                <a:tc>
                  <a:txBody>
                    <a:bodyPr/>
                    <a:lstStyle/>
                    <a:p>
                      <a:r>
                        <a:rPr lang="en-US" sz="600" b="1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il size </a:t>
                      </a: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ll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um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rge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 (16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 (62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 (20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2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 (18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 (44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 (35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(13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 (83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4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0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81, </a:t>
                      </a:r>
                      <a:r>
                        <a:rPr lang="en-US" sz="600" noProof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</a:t>
                      </a:r>
                    </a:p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2886789"/>
                  </a:ext>
                </a:extLst>
              </a:tr>
              <a:tr h="434480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ye </a:t>
                      </a:r>
                      <a:r>
                        <a:rPr lang="en-US" sz="600" b="1" noProof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ur</a:t>
                      </a:r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ght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rk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6 (65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 (33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2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2 (57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 (40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 (75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 (25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0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12, </a:t>
                      </a:r>
                      <a:r>
                        <a:rPr lang="en-US" sz="600" noProof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</a:p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26741926"/>
                  </a:ext>
                </a:extLst>
              </a:tr>
              <a:tr h="711519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age acquisition problems </a:t>
                      </a:r>
                      <a:r>
                        <a:rPr lang="en-US" sz="600" b="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ent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t</a:t>
                      </a:r>
                    </a:p>
                    <a:p>
                      <a:pPr marL="171450" indent="-77788">
                        <a:buFontTx/>
                        <a:buChar char="-"/>
                        <a:tabLst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hnical</a:t>
                      </a:r>
                    </a:p>
                    <a:p>
                      <a:pPr marL="171450" indent="-77788">
                        <a:buFontTx/>
                        <a:buChar char="-"/>
                        <a:tabLst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-related</a:t>
                      </a:r>
                    </a:p>
                    <a:p>
                      <a:pPr marL="171450" indent="-77788">
                        <a:buFontTx/>
                        <a:buChar char="-"/>
                        <a:tabLst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defined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 (58%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2 (42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 (8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 (21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 (13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1 (65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 (35%)</a:t>
                      </a:r>
                    </a:p>
                    <a:p>
                      <a:pPr marL="180975" indent="0">
                        <a:tabLst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9%)</a:t>
                      </a:r>
                    </a:p>
                    <a:p>
                      <a:pPr marL="180975" indent="0">
                        <a:tabLst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3%)</a:t>
                      </a:r>
                    </a:p>
                    <a:p>
                      <a:pPr marL="180975" indent="0">
                        <a:tabLst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 (23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 (50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 (50%)</a:t>
                      </a:r>
                    </a:p>
                    <a:p>
                      <a:pPr marL="180975" indent="0">
                        <a:tabLst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7%)</a:t>
                      </a:r>
                    </a:p>
                    <a:p>
                      <a:pPr marL="180975" indent="0">
                        <a:tabLst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 (41%)</a:t>
                      </a:r>
                    </a:p>
                    <a:p>
                      <a:pPr marL="180975" indent="0">
                        <a:tabLst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2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9, </a:t>
                      </a:r>
                      <a:r>
                        <a:rPr lang="en-US" sz="600" noProof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</a:p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7615316"/>
                  </a:ext>
                </a:extLst>
              </a:tr>
              <a:tr h="711519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normal OCT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ent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t</a:t>
                      </a:r>
                    </a:p>
                    <a:p>
                      <a:pPr marL="171450" indent="-80963">
                        <a:buFontTx/>
                        <a:buChar char="-"/>
                        <a:tabLst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veal</a:t>
                      </a:r>
                    </a:p>
                    <a:p>
                      <a:pPr marL="171450" indent="-80963">
                        <a:buFontTx/>
                        <a:buChar char="-"/>
                        <a:tabLst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rafoveal</a:t>
                      </a:r>
                    </a:p>
                    <a:p>
                      <a:pPr marL="171450" indent="-80963">
                        <a:buFontTx/>
                        <a:buChar char="-"/>
                        <a:tabLst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veal and extrafoveal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3 (42%)</a:t>
                      </a:r>
                    </a:p>
                    <a:p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 (57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(10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(4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 (43%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 (1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 (76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0 (22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(11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7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4%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5(2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3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9 (97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9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2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 (86%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242, </a:t>
                      </a:r>
                      <a:r>
                        <a:rPr lang="en-US" sz="600" noProof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1</a:t>
                      </a:r>
                    </a:p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17263303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ract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ent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t</a:t>
                      </a:r>
                    </a:p>
                    <a:p>
                      <a:pPr marL="171450" indent="-80963">
                        <a:buFontTx/>
                        <a:buChar char="-"/>
                        <a:tabLst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erior capsular cataract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 (52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0 (48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2 (10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 (44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 (56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1 (14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 (61%)</a:t>
                      </a: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 (39%)</a:t>
                      </a:r>
                    </a:p>
                    <a:p>
                      <a:pPr marL="134938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 (5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13, </a:t>
                      </a:r>
                      <a:r>
                        <a:rPr lang="en-US" sz="600" noProof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47595007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904BCBF-0F10-237D-13F7-BD73DD0C32DC}"/>
              </a:ext>
            </a:extLst>
          </p:cNvPr>
          <p:cNvSpPr txBox="1"/>
          <p:nvPr/>
        </p:nvSpPr>
        <p:spPr>
          <a:xfrm>
            <a:off x="696124" y="400275"/>
            <a:ext cx="495940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haracteristics of study participants (n = 230) and eyes (n = 437) with available AO-TFI Images, including adverse events and acquisition problem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33DC70C-E2B4-C20C-3173-2467C7165781}"/>
              </a:ext>
            </a:extLst>
          </p:cNvPr>
          <p:cNvSpPr txBox="1"/>
          <p:nvPr/>
        </p:nvSpPr>
        <p:spPr>
          <a:xfrm>
            <a:off x="573460" y="7974775"/>
            <a:ext cx="58304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lcoxon non-parametric test was used for numeric variables, Chi-squared test for categorical data. </a:t>
            </a:r>
          </a:p>
        </p:txBody>
      </p:sp>
    </p:spTree>
    <p:extLst>
      <p:ext uri="{BB962C8B-B14F-4D97-AF65-F5344CB8AC3E}">
        <p14:creationId xmlns:p14="http://schemas.microsoft.com/office/powerpoint/2010/main" val="3804733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FBB5615-149C-524B-2BA4-095CEEA661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F7C553B-CF7C-9E67-ABD1-B52D5DF8D3D9}"/>
              </a:ext>
            </a:extLst>
          </p:cNvPr>
          <p:cNvSpPr txBox="1"/>
          <p:nvPr/>
        </p:nvSpPr>
        <p:spPr>
          <a:xfrm>
            <a:off x="612318" y="573597"/>
            <a:ext cx="443931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. 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ssociations of subjects' characteristics with AO-TFI image quality, i.e. visible image area (n=1342 images).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0343F5F5-B404-4DF4-5AC4-E6333DA1E2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2997313"/>
              </p:ext>
            </p:extLst>
          </p:nvPr>
        </p:nvGraphicFramePr>
        <p:xfrm>
          <a:off x="680052" y="1089895"/>
          <a:ext cx="4371583" cy="263453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47381">
                  <a:extLst>
                    <a:ext uri="{9D8B030D-6E8A-4147-A177-3AD203B41FA5}">
                      <a16:colId xmlns:a16="http://schemas.microsoft.com/office/drawing/2014/main" val="79550658"/>
                    </a:ext>
                  </a:extLst>
                </a:gridCol>
                <a:gridCol w="874734">
                  <a:extLst>
                    <a:ext uri="{9D8B030D-6E8A-4147-A177-3AD203B41FA5}">
                      <a16:colId xmlns:a16="http://schemas.microsoft.com/office/drawing/2014/main" val="2072024093"/>
                    </a:ext>
                  </a:extLst>
                </a:gridCol>
                <a:gridCol w="874734">
                  <a:extLst>
                    <a:ext uri="{9D8B030D-6E8A-4147-A177-3AD203B41FA5}">
                      <a16:colId xmlns:a16="http://schemas.microsoft.com/office/drawing/2014/main" val="883958064"/>
                    </a:ext>
                  </a:extLst>
                </a:gridCol>
                <a:gridCol w="874734">
                  <a:extLst>
                    <a:ext uri="{9D8B030D-6E8A-4147-A177-3AD203B41FA5}">
                      <a16:colId xmlns:a16="http://schemas.microsoft.com/office/drawing/2014/main" val="3215271149"/>
                    </a:ext>
                  </a:extLst>
                </a:gridCol>
              </a:tblGrid>
              <a:tr h="265811">
                <a:tc>
                  <a:txBody>
                    <a:bodyPr/>
                    <a:lstStyle/>
                    <a:p>
                      <a:pPr algn="ctr" fontAlgn="b"/>
                      <a:r>
                        <a:rPr lang="en-CH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ble image area %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84080148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variate models*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imat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Error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</a:t>
                      </a:r>
                      <a:r>
                        <a:rPr lang="en-GB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&gt;|z|) 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4654969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97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9</a:t>
                      </a:r>
                      <a:endParaRPr lang="en-CH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CH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332279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4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9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4310675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xial length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0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8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680011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igmatism &gt; -1.5D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1925425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marL="136525" indent="0" algn="l" fontAlgn="b">
                        <a:tabLst/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t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1.81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H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3881899"/>
                  </a:ext>
                </a:extLst>
              </a:tr>
              <a:tr h="12786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ye colour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3397161"/>
                  </a:ext>
                </a:extLst>
              </a:tr>
              <a:tr h="127867">
                <a:tc>
                  <a:txBody>
                    <a:bodyPr/>
                    <a:lstStyle/>
                    <a:p>
                      <a:pPr marL="136525" indent="0" algn="l" fontAlgn="b">
                        <a:tabLst/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ght colour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68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1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H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1530039"/>
                  </a:ext>
                </a:extLst>
              </a:tr>
              <a:tr h="12786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ract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1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6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7526529"/>
                  </a:ext>
                </a:extLst>
              </a:tr>
              <a:tr h="127867">
                <a:tc>
                  <a:txBody>
                    <a:bodyPr/>
                    <a:lstStyle/>
                    <a:p>
                      <a:pPr marL="134938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t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66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9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2595185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il siz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CH" sz="8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5610137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marL="134938" indent="0" algn="l" fontAlgn="b">
                        <a:tabLst/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um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55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8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8555962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marL="134938" indent="0" algn="l" fontAlgn="b">
                        <a:tabLst/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ll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89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7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1108960"/>
                  </a:ext>
                </a:extLst>
              </a:tr>
              <a:tr h="24978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age acquisition problems (n)</a:t>
                      </a:r>
                    </a:p>
                    <a:p>
                      <a:pPr marL="134938" indent="0" algn="l" fontAlgn="b">
                        <a:tabLst/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t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4.53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2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4115435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tinal disease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0142394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marL="134938" indent="0">
                        <a:tabLst/>
                      </a:pPr>
                      <a:r>
                        <a:rPr lang="en-US" sz="8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t</a:t>
                      </a: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0.85</a:t>
                      </a: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3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H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4360094"/>
                  </a:ext>
                </a:extLst>
              </a:tr>
              <a:tr h="133956">
                <a:tc>
                  <a:txBody>
                    <a:bodyPr/>
                    <a:lstStyle/>
                    <a:p>
                      <a:pPr marL="134938" indent="0" algn="l" fontAlgn="b">
                        <a:tabLst/>
                      </a:pP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CH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947" marR="5947" marT="594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0675601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FD16D793-2AFD-57F8-0A5C-25120E4A64BE}"/>
              </a:ext>
            </a:extLst>
          </p:cNvPr>
          <p:cNvSpPr txBox="1"/>
          <p:nvPr/>
        </p:nvSpPr>
        <p:spPr>
          <a:xfrm>
            <a:off x="612318" y="3761753"/>
            <a:ext cx="58799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 linear mixed effects models, considering eye as random effect to correct for variable amounts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fo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scans of different eyes. 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1118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1F4F2C-C976-BB98-98D3-43D820FD96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477FD524-A312-D57A-3F2B-98CF63BEDC4F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690980" y="1255800"/>
          <a:ext cx="5476040" cy="474313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41338">
                  <a:extLst>
                    <a:ext uri="{9D8B030D-6E8A-4147-A177-3AD203B41FA5}">
                      <a16:colId xmlns:a16="http://schemas.microsoft.com/office/drawing/2014/main" val="46098115"/>
                    </a:ext>
                  </a:extLst>
                </a:gridCol>
                <a:gridCol w="1049078">
                  <a:extLst>
                    <a:ext uri="{9D8B030D-6E8A-4147-A177-3AD203B41FA5}">
                      <a16:colId xmlns:a16="http://schemas.microsoft.com/office/drawing/2014/main" val="1543340868"/>
                    </a:ext>
                  </a:extLst>
                </a:gridCol>
                <a:gridCol w="1095208">
                  <a:extLst>
                    <a:ext uri="{9D8B030D-6E8A-4147-A177-3AD203B41FA5}">
                      <a16:colId xmlns:a16="http://schemas.microsoft.com/office/drawing/2014/main" val="2231682253"/>
                    </a:ext>
                  </a:extLst>
                </a:gridCol>
                <a:gridCol w="1095208">
                  <a:extLst>
                    <a:ext uri="{9D8B030D-6E8A-4147-A177-3AD203B41FA5}">
                      <a16:colId xmlns:a16="http://schemas.microsoft.com/office/drawing/2014/main" val="1053508996"/>
                    </a:ext>
                  </a:extLst>
                </a:gridCol>
                <a:gridCol w="1095208">
                  <a:extLst>
                    <a:ext uri="{9D8B030D-6E8A-4147-A177-3AD203B41FA5}">
                      <a16:colId xmlns:a16="http://schemas.microsoft.com/office/drawing/2014/main" val="954700391"/>
                    </a:ext>
                  </a:extLst>
                </a:gridCol>
              </a:tblGrid>
              <a:tr h="225419"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cohort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y retina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d retina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s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74812778"/>
                  </a:ext>
                </a:extLst>
              </a:tr>
              <a:tr h="334329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s 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 (58%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(42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45%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55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(66%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34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2,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7944150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years)</a:t>
                      </a:r>
                    </a:p>
                    <a:p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b="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b="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 ± 2.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: 78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 ± 2.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: 78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 ± 2.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: 78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9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308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5511364"/>
                  </a:ext>
                </a:extLst>
              </a:tr>
              <a:tr h="334329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yes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3 (49%) 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 (51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44%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(56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(67%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(33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4,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8631259"/>
                  </a:ext>
                </a:extLst>
              </a:tr>
              <a:tr h="805816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nes with images 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 with ≥ 20% visible area for analysis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3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5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1</a:t>
                      </a: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2</a:t>
                      </a: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</a:t>
                      </a: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1.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0.5,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46956564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ble image area %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 ± 2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: 99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 ± 1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 : 99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± 2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: 98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23152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71925856"/>
                  </a:ext>
                </a:extLst>
              </a:tr>
              <a:tr h="522924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sity of hyperreflective regions (n/mm</a:t>
                      </a:r>
                      <a:r>
                        <a:rPr lang="en-US" sz="600" b="1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 ± 4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: 17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 ± 4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: 150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 ± 39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: 17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13322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0381705"/>
                  </a:ext>
                </a:extLst>
              </a:tr>
              <a:tr h="617221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rea of hyperreflective regions (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µm</a:t>
                      </a:r>
                      <a:r>
                        <a:rPr lang="en-US" sz="600" b="0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5 ± 118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 : 103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 ± 46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: 31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 ± 12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8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 : 103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5515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67250219"/>
                  </a:ext>
                </a:extLst>
              </a:tr>
              <a:tr h="522924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sity of </a:t>
                      </a:r>
                      <a:r>
                        <a:rPr lang="en-US" sz="600" b="1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reflective</a:t>
                      </a:r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gions (n/mm</a:t>
                      </a:r>
                      <a:r>
                        <a:rPr lang="en-US" sz="600" b="1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 ± 38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: 180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 ± 4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: 180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 ± 3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: 17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15055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62499667"/>
                  </a:ext>
                </a:extLst>
              </a:tr>
              <a:tr h="522924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rea of </a:t>
                      </a:r>
                      <a:r>
                        <a:rPr lang="en-US" sz="600" b="1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reflective</a:t>
                      </a:r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gions (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µm</a:t>
                      </a:r>
                      <a:r>
                        <a:rPr lang="en-US" sz="600" b="0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5 ± 11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 : 846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 ± 5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 : 38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 ± 113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 : 846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6360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272850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2EAA6C6-E125-21BE-AF6C-B27594036816}"/>
              </a:ext>
            </a:extLst>
          </p:cNvPr>
          <p:cNvSpPr txBox="1"/>
          <p:nvPr/>
        </p:nvSpPr>
        <p:spPr>
          <a:xfrm>
            <a:off x="612318" y="659008"/>
            <a:ext cx="495940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3a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ge balanced (&gt;69 and &lt;79y) subgroup analysis (subjects n = 60)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027CBEF-FC30-B102-DD0F-CDCBA4C3CA7E}"/>
              </a:ext>
            </a:extLst>
          </p:cNvPr>
          <p:cNvSpPr txBox="1"/>
          <p:nvPr/>
        </p:nvSpPr>
        <p:spPr>
          <a:xfrm>
            <a:off x="1286060" y="700843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graphicFrame>
        <p:nvGraphicFramePr>
          <p:cNvPr id="3" name="Table 4">
            <a:extLst>
              <a:ext uri="{FF2B5EF4-FFF2-40B4-BE49-F238E27FC236}">
                <a16:creationId xmlns:a16="http://schemas.microsoft.com/office/drawing/2014/main" id="{929BEA1A-43D7-36DD-AC7F-D20C33CA34DD}"/>
              </a:ext>
            </a:extLst>
          </p:cNvPr>
          <p:cNvGraphicFramePr>
            <a:graphicFrameLocks/>
          </p:cNvGraphicFramePr>
          <p:nvPr/>
        </p:nvGraphicFramePr>
        <p:xfrm>
          <a:off x="690980" y="6800211"/>
          <a:ext cx="5476040" cy="384302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41338">
                  <a:extLst>
                    <a:ext uri="{9D8B030D-6E8A-4147-A177-3AD203B41FA5}">
                      <a16:colId xmlns:a16="http://schemas.microsoft.com/office/drawing/2014/main" val="46098115"/>
                    </a:ext>
                  </a:extLst>
                </a:gridCol>
                <a:gridCol w="1049078">
                  <a:extLst>
                    <a:ext uri="{9D8B030D-6E8A-4147-A177-3AD203B41FA5}">
                      <a16:colId xmlns:a16="http://schemas.microsoft.com/office/drawing/2014/main" val="1543340868"/>
                    </a:ext>
                  </a:extLst>
                </a:gridCol>
                <a:gridCol w="1095208">
                  <a:extLst>
                    <a:ext uri="{9D8B030D-6E8A-4147-A177-3AD203B41FA5}">
                      <a16:colId xmlns:a16="http://schemas.microsoft.com/office/drawing/2014/main" val="2231682253"/>
                    </a:ext>
                  </a:extLst>
                </a:gridCol>
                <a:gridCol w="1095208">
                  <a:extLst>
                    <a:ext uri="{9D8B030D-6E8A-4147-A177-3AD203B41FA5}">
                      <a16:colId xmlns:a16="http://schemas.microsoft.com/office/drawing/2014/main" val="1053508996"/>
                    </a:ext>
                  </a:extLst>
                </a:gridCol>
                <a:gridCol w="1095208">
                  <a:extLst>
                    <a:ext uri="{9D8B030D-6E8A-4147-A177-3AD203B41FA5}">
                      <a16:colId xmlns:a16="http://schemas.microsoft.com/office/drawing/2014/main" val="954700391"/>
                    </a:ext>
                  </a:extLst>
                </a:gridCol>
              </a:tblGrid>
              <a:tr h="225419"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cohort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y retina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d retina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s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74812778"/>
                  </a:ext>
                </a:extLst>
              </a:tr>
              <a:tr h="334329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s 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55%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45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31%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69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89%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5,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7944150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years)</a:t>
                      </a:r>
                    </a:p>
                    <a:p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b="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b="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 ± 2.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: 7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 ± 2.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: 7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 ± 2.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: 7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6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50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5511364"/>
                  </a:ext>
                </a:extLst>
              </a:tr>
              <a:tr h="334329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yes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60%) 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40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6%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64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91%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9%)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6,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8631259"/>
                  </a:ext>
                </a:extLst>
              </a:tr>
              <a:tr h="805816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nes with images 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) with ≥ 20% visible area for analysis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3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5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r>
                        <a:rPr lang="en-US" sz="600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2,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46956564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saic over visible area %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± 1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: 58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± 1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: 58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± 1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: 52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4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262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7435301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sity of RPE (n/mm</a:t>
                      </a:r>
                      <a:r>
                        <a:rPr lang="en-US" sz="600" b="1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05 ± 693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51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66 : 8203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71 ± 668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6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66 : 7980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77 ± 758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4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98 : 8203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6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277</a:t>
                      </a:r>
                    </a:p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1500376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Cell Area Raw 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</a:t>
                      </a:r>
                      <a:r>
                        <a:rPr lang="en-US" sz="600" b="0" baseline="300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 ± 16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 : 18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0 ± 1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 : 18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 ± 1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 : 18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6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337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2886789"/>
                  </a:ext>
                </a:extLst>
              </a:tr>
              <a:tr h="428626">
                <a:tc>
                  <a:txBody>
                    <a:bodyPr/>
                    <a:lstStyle/>
                    <a:p>
                      <a:r>
                        <a:rPr lang="en-US" sz="600" b="1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Cell Perimeter </a:t>
                      </a:r>
                      <a:r>
                        <a:rPr lang="en-US" sz="600" b="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</a:t>
                      </a:r>
                      <a:r>
                        <a:rPr lang="en-US" sz="600" noProof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 : max 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± 2.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 : 5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± 2.5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: 5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 ± 2.7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 : 54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600" noProof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3</a:t>
                      </a:r>
                    </a:p>
                    <a:p>
                      <a:r>
                        <a:rPr lang="en-US" sz="6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= 9420</a:t>
                      </a:r>
                    </a:p>
                  </a:txBody>
                  <a:tcPr marL="51435" marR="51435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26741926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61A7D1A4-A0E5-673D-C25A-C67406A298E5}"/>
              </a:ext>
            </a:extLst>
          </p:cNvPr>
          <p:cNvSpPr txBox="1"/>
          <p:nvPr/>
        </p:nvSpPr>
        <p:spPr>
          <a:xfrm>
            <a:off x="612318" y="6251415"/>
            <a:ext cx="5554702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57206">
              <a:defRPr/>
            </a:pP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S3b. 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 balanced (&gt;69 and &lt;79y) subgroup RPE analysis (subjects n = 22)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CD14220-F75C-8EEE-3972-8FE6041608BD}"/>
              </a:ext>
            </a:extLst>
          </p:cNvPr>
          <p:cNvSpPr txBox="1"/>
          <p:nvPr/>
        </p:nvSpPr>
        <p:spPr>
          <a:xfrm>
            <a:off x="612318" y="10761143"/>
            <a:ext cx="58304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lcoxon non-parametric test was used for numeric variables, Chi-squared test for categorical data. </a:t>
            </a:r>
          </a:p>
        </p:txBody>
      </p:sp>
    </p:spTree>
    <p:extLst>
      <p:ext uri="{BB962C8B-B14F-4D97-AF65-F5344CB8AC3E}">
        <p14:creationId xmlns:p14="http://schemas.microsoft.com/office/powerpoint/2010/main" val="3547131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6909</TotalTime>
  <Words>1716</Words>
  <Application>Microsoft Macintosh PowerPoint</Application>
  <PresentationFormat>Widescreen</PresentationFormat>
  <Paragraphs>702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ppenberger  Leila</dc:creator>
  <cp:lastModifiedBy>Leila Eppenberger</cp:lastModifiedBy>
  <cp:revision>193</cp:revision>
  <cp:lastPrinted>2023-07-10T13:52:50Z</cp:lastPrinted>
  <dcterms:created xsi:type="dcterms:W3CDTF">2023-07-09T18:33:52Z</dcterms:created>
  <dcterms:modified xsi:type="dcterms:W3CDTF">2025-09-01T20:13:59Z</dcterms:modified>
</cp:coreProperties>
</file>